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66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72" autoAdjust="0"/>
    <p:restoredTop sz="94660"/>
  </p:normalViewPr>
  <p:slideViewPr>
    <p:cSldViewPr snapToGrid="0">
      <p:cViewPr varScale="1">
        <p:scale>
          <a:sx n="58" d="100"/>
          <a:sy n="58" d="100"/>
        </p:scale>
        <p:origin x="2400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5398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4603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0471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170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97238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560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16592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65643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0693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191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53528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791629-7324-4072-A4FD-C7E82E8A4AD3}" type="datetimeFigureOut">
              <a:rPr kumimoji="1" lang="ja-JP" altLang="en-US" smtClean="0"/>
              <a:t>2022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F89D49-10D6-49DF-983F-5E081A5BCA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4487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DE2F52A-78B1-4FBD-804B-A30ECC88351D}"/>
              </a:ext>
            </a:extLst>
          </p:cNvPr>
          <p:cNvSpPr txBox="1"/>
          <p:nvPr/>
        </p:nvSpPr>
        <p:spPr>
          <a:xfrm>
            <a:off x="623147" y="701040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D5762A03-7D94-4E7A-B322-BDD1EDC867B7}"/>
              </a:ext>
            </a:extLst>
          </p:cNvPr>
          <p:cNvGrpSpPr/>
          <p:nvPr/>
        </p:nvGrpSpPr>
        <p:grpSpPr>
          <a:xfrm>
            <a:off x="482883" y="1519495"/>
            <a:ext cx="6006535" cy="3214073"/>
            <a:chOff x="425733" y="1405195"/>
            <a:chExt cx="6006535" cy="3214073"/>
          </a:xfrm>
        </p:grpSpPr>
        <p:pic>
          <p:nvPicPr>
            <p:cNvPr id="4" name="図 3">
              <a:extLst>
                <a:ext uri="{FF2B5EF4-FFF2-40B4-BE49-F238E27FC236}">
                  <a16:creationId xmlns:a16="http://schemas.microsoft.com/office/drawing/2014/main" id="{15CF6A7C-3A92-423B-9CAB-2B3C0A40A0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35" t="1120" r="565" b="5532"/>
            <a:stretch/>
          </p:blipFill>
          <p:spPr>
            <a:xfrm>
              <a:off x="702733" y="1676400"/>
              <a:ext cx="5272618" cy="2654300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D4CAB7A2-E9F4-4DE7-B4F1-54D2EDA37AFE}"/>
                </a:ext>
              </a:extLst>
            </p:cNvPr>
            <p:cNvSpPr txBox="1"/>
            <p:nvPr/>
          </p:nvSpPr>
          <p:spPr>
            <a:xfrm>
              <a:off x="3080798" y="4342269"/>
              <a:ext cx="5164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ate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1854D5C4-36F6-4CC6-B541-9FC3085DA0DD}"/>
                </a:ext>
              </a:extLst>
            </p:cNvPr>
            <p:cNvSpPr txBox="1"/>
            <p:nvPr/>
          </p:nvSpPr>
          <p:spPr>
            <a:xfrm rot="16200000">
              <a:off x="-229414" y="2865050"/>
              <a:ext cx="15872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Number of patients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7AC2B58B-FC8F-4CAE-AEED-BBE05C359017}"/>
                </a:ext>
              </a:extLst>
            </p:cNvPr>
            <p:cNvSpPr txBox="1"/>
            <p:nvPr/>
          </p:nvSpPr>
          <p:spPr>
            <a:xfrm rot="16200000">
              <a:off x="4603081" y="2772717"/>
              <a:ext cx="319670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Proportion of shifting </a:t>
              </a:r>
            </a:p>
            <a:p>
              <a:pPr algn="ctr"/>
              <a:r>
                <a:rPr kumimoji="1"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rom mechanical ventilation to ECMO (%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79893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7</TotalTime>
  <Words>16</Words>
  <Application>Microsoft Office PowerPoint</Application>
  <PresentationFormat>A4 210 x 297 mm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ichiro Ohshimo</dc:creator>
  <cp:lastModifiedBy>Shinichiro Ohshimo</cp:lastModifiedBy>
  <cp:revision>70</cp:revision>
  <dcterms:created xsi:type="dcterms:W3CDTF">2022-01-17T15:20:27Z</dcterms:created>
  <dcterms:modified xsi:type="dcterms:W3CDTF">2022-06-17T21:07:49Z</dcterms:modified>
</cp:coreProperties>
</file>